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xlsx" ContentType="application/vnd.openxmlformats-officedocument.spreadsheetml.sheet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08"/>
    <p:restoredTop sz="94590"/>
  </p:normalViewPr>
  <p:slideViewPr>
    <p:cSldViewPr snapToGrid="0" snapToObjects="1">
      <p:cViewPr varScale="1">
        <p:scale>
          <a:sx n="92" d="100"/>
          <a:sy n="92" d="100"/>
        </p:scale>
        <p:origin x="1664" y="19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ZA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/>
      <c:barChart>
        <c:barDir val="bar"/>
        <c:grouping val="percentStack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Good quality/low risk bias</c:v>
                </c:pt>
              </c:strCache>
            </c:strRef>
          </c:tx>
          <c:spPr>
            <a:solidFill>
              <a:srgbClr val="008000"/>
            </a:solidFill>
          </c:spPr>
          <c:invertIfNegative val="0"/>
          <c:cat>
            <c:strRef>
              <c:f>Sheet1!$A$2:$A$8</c:f>
              <c:strCache>
                <c:ptCount val="7"/>
                <c:pt idx="0">
                  <c:v>Bias</c:v>
                </c:pt>
                <c:pt idx="1">
                  <c:v>Study design</c:v>
                </c:pt>
                <c:pt idx="2">
                  <c:v>Study objective</c:v>
                </c:pt>
                <c:pt idx="3">
                  <c:v>Denominator</c:v>
                </c:pt>
                <c:pt idx="4">
                  <c:v>Diagnosis</c:v>
                </c:pt>
                <c:pt idx="5">
                  <c:v>Numerator</c:v>
                </c:pt>
                <c:pt idx="6">
                  <c:v>Overall quality</c:v>
                </c:pt>
              </c:strCache>
            </c:strRef>
          </c:cat>
          <c:val>
            <c:numRef>
              <c:f>Sheet1!$B$2:$B$8</c:f>
              <c:numCache>
                <c:formatCode>General</c:formatCode>
                <c:ptCount val="7"/>
                <c:pt idx="0">
                  <c:v>6.0</c:v>
                </c:pt>
                <c:pt idx="1">
                  <c:v>42.0</c:v>
                </c:pt>
                <c:pt idx="2">
                  <c:v>14.0</c:v>
                </c:pt>
                <c:pt idx="3">
                  <c:v>40.0</c:v>
                </c:pt>
                <c:pt idx="4">
                  <c:v>45.0</c:v>
                </c:pt>
                <c:pt idx="5">
                  <c:v>35.0</c:v>
                </c:pt>
                <c:pt idx="6">
                  <c:v>3.0</c:v>
                </c:pt>
              </c:numCache>
            </c:numRef>
          </c:val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Moderate quality/uncertain risk bias</c:v>
                </c:pt>
              </c:strCache>
            </c:strRef>
          </c:tx>
          <c:spPr>
            <a:solidFill>
              <a:srgbClr val="FFFF00"/>
            </a:solidFill>
          </c:spPr>
          <c:invertIfNegative val="0"/>
          <c:cat>
            <c:strRef>
              <c:f>Sheet1!$A$2:$A$8</c:f>
              <c:strCache>
                <c:ptCount val="7"/>
                <c:pt idx="0">
                  <c:v>Bias</c:v>
                </c:pt>
                <c:pt idx="1">
                  <c:v>Study design</c:v>
                </c:pt>
                <c:pt idx="2">
                  <c:v>Study objective</c:v>
                </c:pt>
                <c:pt idx="3">
                  <c:v>Denominator</c:v>
                </c:pt>
                <c:pt idx="4">
                  <c:v>Diagnosis</c:v>
                </c:pt>
                <c:pt idx="5">
                  <c:v>Numerator</c:v>
                </c:pt>
                <c:pt idx="6">
                  <c:v>Overall quality</c:v>
                </c:pt>
              </c:strCache>
            </c:strRef>
          </c:cat>
          <c:val>
            <c:numRef>
              <c:f>Sheet1!$C$2:$C$8</c:f>
              <c:numCache>
                <c:formatCode>General</c:formatCode>
                <c:ptCount val="7"/>
                <c:pt idx="0">
                  <c:v>12.0</c:v>
                </c:pt>
                <c:pt idx="1">
                  <c:v>0.0</c:v>
                </c:pt>
                <c:pt idx="2">
                  <c:v>28.0</c:v>
                </c:pt>
                <c:pt idx="3">
                  <c:v>0.0</c:v>
                </c:pt>
                <c:pt idx="4">
                  <c:v>0.0</c:v>
                </c:pt>
                <c:pt idx="5">
                  <c:v>0.0</c:v>
                </c:pt>
                <c:pt idx="6">
                  <c:v>24.0</c:v>
                </c:pt>
              </c:numCache>
            </c:numRef>
          </c:val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Poor quality/high risk bias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cat>
            <c:strRef>
              <c:f>Sheet1!$A$2:$A$8</c:f>
              <c:strCache>
                <c:ptCount val="7"/>
                <c:pt idx="0">
                  <c:v>Bias</c:v>
                </c:pt>
                <c:pt idx="1">
                  <c:v>Study design</c:v>
                </c:pt>
                <c:pt idx="2">
                  <c:v>Study objective</c:v>
                </c:pt>
                <c:pt idx="3">
                  <c:v>Denominator</c:v>
                </c:pt>
                <c:pt idx="4">
                  <c:v>Diagnosis</c:v>
                </c:pt>
                <c:pt idx="5">
                  <c:v>Numerator</c:v>
                </c:pt>
                <c:pt idx="6">
                  <c:v>Overall quality</c:v>
                </c:pt>
              </c:strCache>
            </c:strRef>
          </c:cat>
          <c:val>
            <c:numRef>
              <c:f>Sheet1!$D$2:$D$8</c:f>
              <c:numCache>
                <c:formatCode>General</c:formatCode>
                <c:ptCount val="7"/>
                <c:pt idx="0">
                  <c:v>30.0</c:v>
                </c:pt>
                <c:pt idx="1">
                  <c:v>11.0</c:v>
                </c:pt>
                <c:pt idx="2">
                  <c:v>6.0</c:v>
                </c:pt>
                <c:pt idx="3">
                  <c:v>6.0</c:v>
                </c:pt>
                <c:pt idx="4">
                  <c:v>3.0</c:v>
                </c:pt>
                <c:pt idx="5">
                  <c:v>11.0</c:v>
                </c:pt>
                <c:pt idx="6">
                  <c:v>19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-2118274720"/>
        <c:axId val="-2144319488"/>
      </c:barChart>
      <c:catAx>
        <c:axId val="-2118274720"/>
        <c:scaling>
          <c:orientation val="minMax"/>
        </c:scaling>
        <c:delete val="0"/>
        <c:axPos val="l"/>
        <c:numFmt formatCode="General" sourceLinked="0"/>
        <c:majorTickMark val="out"/>
        <c:minorTickMark val="none"/>
        <c:tickLblPos val="nextTo"/>
        <c:crossAx val="-2144319488"/>
        <c:crosses val="autoZero"/>
        <c:auto val="1"/>
        <c:lblAlgn val="ctr"/>
        <c:lblOffset val="100"/>
        <c:noMultiLvlLbl val="0"/>
      </c:catAx>
      <c:valAx>
        <c:axId val="-2144319488"/>
        <c:scaling>
          <c:orientation val="minMax"/>
        </c:scaling>
        <c:delete val="1"/>
        <c:axPos val="b"/>
        <c:majorGridlines/>
        <c:numFmt formatCode="0%" sourceLinked="1"/>
        <c:majorTickMark val="out"/>
        <c:minorTickMark val="none"/>
        <c:tickLblPos val="nextTo"/>
        <c:crossAx val="-2118274720"/>
        <c:crosses val="autoZero"/>
        <c:crossBetween val="between"/>
      </c:valAx>
    </c:plotArea>
    <c:legend>
      <c:legendPos val="t"/>
      <c:layout/>
      <c:overlay val="0"/>
    </c:legend>
    <c:plotVisOnly val="1"/>
    <c:dispBlanksAs val="gap"/>
    <c:showDLblsOverMax val="0"/>
  </c:chart>
  <c:txPr>
    <a:bodyPr/>
    <a:lstStyle/>
    <a:p>
      <a:pPr>
        <a:defRPr sz="1800"/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AD244F-86C4-6448-AC9D-5A54C8E26A94}" type="datetimeFigureOut">
              <a:rPr lang="en-US" smtClean="0"/>
              <a:t>12/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032459-BF8E-7748-8E64-C6C10249D4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32472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AD244F-86C4-6448-AC9D-5A54C8E26A94}" type="datetimeFigureOut">
              <a:rPr lang="en-US" smtClean="0"/>
              <a:t>12/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032459-BF8E-7748-8E64-C6C10249D4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58798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AD244F-86C4-6448-AC9D-5A54C8E26A94}" type="datetimeFigureOut">
              <a:rPr lang="en-US" smtClean="0"/>
              <a:t>12/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032459-BF8E-7748-8E64-C6C10249D4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49936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AD244F-86C4-6448-AC9D-5A54C8E26A94}" type="datetimeFigureOut">
              <a:rPr lang="en-US" smtClean="0"/>
              <a:t>12/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032459-BF8E-7748-8E64-C6C10249D4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82442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AD244F-86C4-6448-AC9D-5A54C8E26A94}" type="datetimeFigureOut">
              <a:rPr lang="en-US" smtClean="0"/>
              <a:t>12/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032459-BF8E-7748-8E64-C6C10249D4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80086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AD244F-86C4-6448-AC9D-5A54C8E26A94}" type="datetimeFigureOut">
              <a:rPr lang="en-US" smtClean="0"/>
              <a:t>12/9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032459-BF8E-7748-8E64-C6C10249D4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62707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AD244F-86C4-6448-AC9D-5A54C8E26A94}" type="datetimeFigureOut">
              <a:rPr lang="en-US" smtClean="0"/>
              <a:t>12/9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032459-BF8E-7748-8E64-C6C10249D4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88091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AD244F-86C4-6448-AC9D-5A54C8E26A94}" type="datetimeFigureOut">
              <a:rPr lang="en-US" smtClean="0"/>
              <a:t>12/9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032459-BF8E-7748-8E64-C6C10249D4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16724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AD244F-86C4-6448-AC9D-5A54C8E26A94}" type="datetimeFigureOut">
              <a:rPr lang="en-US" smtClean="0"/>
              <a:t>12/9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032459-BF8E-7748-8E64-C6C10249D4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69757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AD244F-86C4-6448-AC9D-5A54C8E26A94}" type="datetimeFigureOut">
              <a:rPr lang="en-US" smtClean="0"/>
              <a:t>12/9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032459-BF8E-7748-8E64-C6C10249D4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84602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AD244F-86C4-6448-AC9D-5A54C8E26A94}" type="datetimeFigureOut">
              <a:rPr lang="en-US" smtClean="0"/>
              <a:t>12/9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032459-BF8E-7748-8E64-C6C10249D4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82751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AD244F-86C4-6448-AC9D-5A54C8E26A94}" type="datetimeFigureOut">
              <a:rPr lang="en-US" smtClean="0"/>
              <a:t>12/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032459-BF8E-7748-8E64-C6C10249D4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33562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ontent Placeholder 3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519677824"/>
              </p:ext>
            </p:extLst>
          </p:nvPr>
        </p:nvGraphicFramePr>
        <p:xfrm>
          <a:off x="457200" y="1600200"/>
          <a:ext cx="8229600" cy="45259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457200" y="6149009"/>
            <a:ext cx="70952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Quality </a:t>
            </a:r>
            <a:r>
              <a:rPr lang="en-US" b="1" dirty="0"/>
              <a:t>assessment and risk of </a:t>
            </a:r>
            <a:r>
              <a:rPr lang="en-US" b="1" dirty="0" smtClean="0"/>
              <a:t>bias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26646034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4</TotalTime>
  <Words>6</Words>
  <Application>Microsoft Macintosh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sean.wasserman@gmail.com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ean Wasserman</dc:creator>
  <cp:lastModifiedBy>Sean Wasserman</cp:lastModifiedBy>
  <cp:revision>4</cp:revision>
  <dcterms:created xsi:type="dcterms:W3CDTF">2015-01-31T18:33:21Z</dcterms:created>
  <dcterms:modified xsi:type="dcterms:W3CDTF">2015-12-09T20:09:21Z</dcterms:modified>
</cp:coreProperties>
</file>